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940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élix Sauvage" userId="dfa1ca22-681e-4356-b559-2b71df22c6fe" providerId="ADAL" clId="{8BC7D00C-BDBE-4922-88A6-7EE0AE7CDA5A}"/>
    <pc:docChg chg="modSld">
      <pc:chgData name="Félix Sauvage" userId="dfa1ca22-681e-4356-b559-2b71df22c6fe" providerId="ADAL" clId="{8BC7D00C-BDBE-4922-88A6-7EE0AE7CDA5A}" dt="2025-09-14T16:44:13.327" v="35" actId="20577"/>
      <pc:docMkLst>
        <pc:docMk/>
      </pc:docMkLst>
      <pc:sldChg chg="modSp mod">
        <pc:chgData name="Félix Sauvage" userId="dfa1ca22-681e-4356-b559-2b71df22c6fe" providerId="ADAL" clId="{8BC7D00C-BDBE-4922-88A6-7EE0AE7CDA5A}" dt="2025-09-14T16:43:48.590" v="5" actId="20577"/>
        <pc:sldMkLst>
          <pc:docMk/>
          <pc:sldMk cId="2913043624" sldId="256"/>
        </pc:sldMkLst>
        <pc:spChg chg="mod">
          <ac:chgData name="Félix Sauvage" userId="dfa1ca22-681e-4356-b559-2b71df22c6fe" providerId="ADAL" clId="{8BC7D00C-BDBE-4922-88A6-7EE0AE7CDA5A}" dt="2025-09-14T16:43:48.590" v="5" actId="20577"/>
          <ac:spMkLst>
            <pc:docMk/>
            <pc:sldMk cId="2913043624" sldId="256"/>
            <ac:spMk id="2" creationId="{BE53406F-DECE-35F7-BC82-C54DC2E48818}"/>
          </ac:spMkLst>
        </pc:spChg>
      </pc:sldChg>
      <pc:sldChg chg="modSp mod">
        <pc:chgData name="Félix Sauvage" userId="dfa1ca22-681e-4356-b559-2b71df22c6fe" providerId="ADAL" clId="{8BC7D00C-BDBE-4922-88A6-7EE0AE7CDA5A}" dt="2025-09-14T16:43:52.925" v="10" actId="20577"/>
        <pc:sldMkLst>
          <pc:docMk/>
          <pc:sldMk cId="620018120" sldId="257"/>
        </pc:sldMkLst>
        <pc:spChg chg="mod">
          <ac:chgData name="Félix Sauvage" userId="dfa1ca22-681e-4356-b559-2b71df22c6fe" providerId="ADAL" clId="{8BC7D00C-BDBE-4922-88A6-7EE0AE7CDA5A}" dt="2025-09-14T16:43:52.925" v="10" actId="20577"/>
          <ac:spMkLst>
            <pc:docMk/>
            <pc:sldMk cId="620018120" sldId="257"/>
            <ac:spMk id="2" creationId="{7CBD4538-A974-1F3D-974D-30AB91EB95E9}"/>
          </ac:spMkLst>
        </pc:spChg>
      </pc:sldChg>
      <pc:sldChg chg="modSp mod">
        <pc:chgData name="Félix Sauvage" userId="dfa1ca22-681e-4356-b559-2b71df22c6fe" providerId="ADAL" clId="{8BC7D00C-BDBE-4922-88A6-7EE0AE7CDA5A}" dt="2025-09-14T16:43:56.867" v="15" actId="20577"/>
        <pc:sldMkLst>
          <pc:docMk/>
          <pc:sldMk cId="2997823628" sldId="258"/>
        </pc:sldMkLst>
        <pc:spChg chg="mod">
          <ac:chgData name="Félix Sauvage" userId="dfa1ca22-681e-4356-b559-2b71df22c6fe" providerId="ADAL" clId="{8BC7D00C-BDBE-4922-88A6-7EE0AE7CDA5A}" dt="2025-09-14T16:43:56.867" v="15" actId="20577"/>
          <ac:spMkLst>
            <pc:docMk/>
            <pc:sldMk cId="2997823628" sldId="258"/>
            <ac:spMk id="2" creationId="{49E3D402-DCCC-E47E-4597-38B2ADCA9691}"/>
          </ac:spMkLst>
        </pc:spChg>
      </pc:sldChg>
      <pc:sldChg chg="modSp mod">
        <pc:chgData name="Félix Sauvage" userId="dfa1ca22-681e-4356-b559-2b71df22c6fe" providerId="ADAL" clId="{8BC7D00C-BDBE-4922-88A6-7EE0AE7CDA5A}" dt="2025-09-14T16:44:00.303" v="20" actId="20577"/>
        <pc:sldMkLst>
          <pc:docMk/>
          <pc:sldMk cId="1968344312" sldId="259"/>
        </pc:sldMkLst>
        <pc:spChg chg="mod">
          <ac:chgData name="Félix Sauvage" userId="dfa1ca22-681e-4356-b559-2b71df22c6fe" providerId="ADAL" clId="{8BC7D00C-BDBE-4922-88A6-7EE0AE7CDA5A}" dt="2025-09-14T16:44:00.303" v="20" actId="20577"/>
          <ac:spMkLst>
            <pc:docMk/>
            <pc:sldMk cId="1968344312" sldId="259"/>
            <ac:spMk id="2" creationId="{A3B27908-050A-99D3-6204-DC855CAF4565}"/>
          </ac:spMkLst>
        </pc:spChg>
      </pc:sldChg>
      <pc:sldChg chg="modSp mod">
        <pc:chgData name="Félix Sauvage" userId="dfa1ca22-681e-4356-b559-2b71df22c6fe" providerId="ADAL" clId="{8BC7D00C-BDBE-4922-88A6-7EE0AE7CDA5A}" dt="2025-09-14T16:44:04.658" v="25" actId="20577"/>
        <pc:sldMkLst>
          <pc:docMk/>
          <pc:sldMk cId="2894482069" sldId="260"/>
        </pc:sldMkLst>
        <pc:spChg chg="mod">
          <ac:chgData name="Félix Sauvage" userId="dfa1ca22-681e-4356-b559-2b71df22c6fe" providerId="ADAL" clId="{8BC7D00C-BDBE-4922-88A6-7EE0AE7CDA5A}" dt="2025-09-14T16:44:04.658" v="25" actId="20577"/>
          <ac:spMkLst>
            <pc:docMk/>
            <pc:sldMk cId="2894482069" sldId="260"/>
            <ac:spMk id="2" creationId="{11388B74-CCE6-229B-265F-7346C6A1AD64}"/>
          </ac:spMkLst>
        </pc:spChg>
      </pc:sldChg>
      <pc:sldChg chg="modSp mod">
        <pc:chgData name="Félix Sauvage" userId="dfa1ca22-681e-4356-b559-2b71df22c6fe" providerId="ADAL" clId="{8BC7D00C-BDBE-4922-88A6-7EE0AE7CDA5A}" dt="2025-09-14T16:44:09.646" v="30" actId="20577"/>
        <pc:sldMkLst>
          <pc:docMk/>
          <pc:sldMk cId="821610390" sldId="261"/>
        </pc:sldMkLst>
        <pc:spChg chg="mod">
          <ac:chgData name="Félix Sauvage" userId="dfa1ca22-681e-4356-b559-2b71df22c6fe" providerId="ADAL" clId="{8BC7D00C-BDBE-4922-88A6-7EE0AE7CDA5A}" dt="2025-09-14T16:44:09.646" v="30" actId="20577"/>
          <ac:spMkLst>
            <pc:docMk/>
            <pc:sldMk cId="821610390" sldId="261"/>
            <ac:spMk id="2" creationId="{289B6350-B223-0608-764F-43637ECF9E61}"/>
          </ac:spMkLst>
        </pc:spChg>
      </pc:sldChg>
      <pc:sldChg chg="modSp mod">
        <pc:chgData name="Félix Sauvage" userId="dfa1ca22-681e-4356-b559-2b71df22c6fe" providerId="ADAL" clId="{8BC7D00C-BDBE-4922-88A6-7EE0AE7CDA5A}" dt="2025-09-14T16:44:13.327" v="35" actId="20577"/>
        <pc:sldMkLst>
          <pc:docMk/>
          <pc:sldMk cId="2476326111" sldId="262"/>
        </pc:sldMkLst>
        <pc:spChg chg="mod">
          <ac:chgData name="Félix Sauvage" userId="dfa1ca22-681e-4356-b559-2b71df22c6fe" providerId="ADAL" clId="{8BC7D00C-BDBE-4922-88A6-7EE0AE7CDA5A}" dt="2025-09-14T16:44:13.327" v="35" actId="20577"/>
          <ac:spMkLst>
            <pc:docMk/>
            <pc:sldMk cId="2476326111" sldId="262"/>
            <ac:spMk id="2" creationId="{9E509D7A-5FD9-FC7D-3B07-D5C4488DE67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53BFF-1080-8626-27A1-7ECFE2DD2C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6DD38A-2A7B-760C-E4B6-6E1D07FD95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12822-1DB6-03F8-F6B9-605B9F4C5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4B9C6-6C66-9C4A-2E2F-78384A87C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51134-9E88-2F9B-49F0-D3FB66F28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782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329B64-5D3F-7F08-91FA-F19C46A59B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80C080-37B0-11C0-909D-FB9AFF762E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7BF9A-CA49-057F-B0EF-5564E7860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E1EDBD-F395-5FA5-8090-EA5B38D86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4633AC-E699-5457-4626-AFE42D8CD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31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7A5D01-1051-CA99-B4EF-D9A3EFD658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0D94FA-2AAE-CA50-303D-2B9D8C24BB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56AA4F-9EE1-C85A-9058-F5613069D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407609-004D-06DF-2B50-27FC7AD2A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B612C-50F7-B68F-A94B-3683C1725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533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59989B-B3BF-ABE8-7FFC-159C1D080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FDB5BB-5728-F46A-2769-6921529A13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6ACF23-51C8-5465-1438-2343677A5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857430-D0C9-AE73-E37F-A778C633A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56B05A-BBF8-F564-C828-F3778FA2B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013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51C11E-0AD2-A62C-39F8-B500CBF5B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81E23F-37FB-220E-1DA1-2A6A49D854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4F9DC-8125-AB74-EE99-3E4F1F33EA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6B8253-3823-E927-92F3-30EAB11B0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30C839-199A-122C-A574-DBB3A2CDC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96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414BB7-9E94-6B1F-C74C-6FDF92D8E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7F374F-D704-BDDA-B767-DFA571396F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846C37-D66D-9714-7CC7-CA99F77437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5E14B4-CB07-A1B0-86C8-C3818920A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864ADC-9D8E-4DF4-D7AF-55A8406A7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05F664-740F-BDBA-85BF-1F7D71092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4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7289F-35E1-2EDE-7B2D-86DA6032A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DED44C-C4DD-BEE9-A46E-D3E6D2DA0B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7BAC09-68DE-614F-746D-76639D645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760A15-FF2E-8A20-5BB5-EBCD845A47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477436-1E03-C5FF-9403-8665E1F983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A1D090-15A0-014A-FF31-E4310302E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E1681F-4E9D-BFF3-A582-8C16D4644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529634-D268-758C-B94E-AF91B1F1A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969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A068F-C751-AE3B-2D51-3CABECA07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8B03C5-32C0-7300-69F2-DB28C822C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7F2652-4327-D10C-4BBE-56C86138D7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0B9BC9-0573-0749-E23E-83E454843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01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8C6C19-2205-69E4-54A4-B65862244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2586A2-21E4-7119-63D2-95C99A732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C13B81-E986-44BF-4D64-2C5C5D0EE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173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6C4D9-DDC5-D787-D3E9-AF9B84BC00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42616-3EF3-8973-C3E0-2FF429054D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15BF20-5116-C482-C674-B914A1A74E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8F51FE-A44D-6BF4-1B79-5895D3DC4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54AD7E-565B-5064-3038-0498162A2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343348-76A1-CD8A-21B0-3CFD0F753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411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3F84C-78E5-C633-857D-D8A9615C3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F41BD9-8D8D-1CFB-DB5E-093512248B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9E9250-5792-5463-530E-2ADC3A8E70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FE9B3B-FBCD-CED5-116C-F3D5424B9C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4A6ECA-854B-EF0A-C3C3-19412DC8E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EB5C95-880F-F602-6AC1-989E11A90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619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FD62C2-D993-50C6-6114-ED8D4D130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835A10-7842-9954-F6BB-4F08C2C856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B0A132-112D-D8A7-21D3-9AF3ED9D20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1B93F6-F264-4A24-BD5D-F4C6944FB6B9}" type="datetimeFigureOut">
              <a:rPr lang="en-US" smtClean="0"/>
              <a:t>9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E234FA-124F-D206-8A7B-8E5FDF46EB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C220BD-9BA4-736F-8D8E-6226385C67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E4E2E14-1FEB-4ACA-BF2E-055768D97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590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1.mp4"/><Relationship Id="rId1" Type="http://schemas.openxmlformats.org/officeDocument/2006/relationships/video" Target="NULL" TargetMode="Externa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4.mp4"/><Relationship Id="rId1" Type="http://schemas.openxmlformats.org/officeDocument/2006/relationships/video" Target="NULL" TargetMode="Externa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5.mp4"/><Relationship Id="rId1" Type="http://schemas.openxmlformats.org/officeDocument/2006/relationships/video" Target="NULL" TargetMode="External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6.mp4"/><Relationship Id="rId1" Type="http://schemas.openxmlformats.org/officeDocument/2006/relationships/video" Target="NULL" TargetMode="Externa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53406F-DECE-35F7-BC82-C54DC2E4881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ovies</a:t>
            </a:r>
          </a:p>
        </p:txBody>
      </p:sp>
    </p:spTree>
    <p:extLst>
      <p:ext uri="{BB962C8B-B14F-4D97-AF65-F5344CB8AC3E}">
        <p14:creationId xmlns:p14="http://schemas.microsoft.com/office/powerpoint/2010/main" val="2913043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BD4538-A974-1F3D-974D-30AB91EB9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1</a:t>
            </a:r>
          </a:p>
        </p:txBody>
      </p:sp>
      <p:pic>
        <p:nvPicPr>
          <p:cNvPr id="4" name="Supplementary Movie S1">
            <a:hlinkClick r:id="" action="ppaction://media"/>
            <a:extLst>
              <a:ext uri="{FF2B5EF4-FFF2-40B4-BE49-F238E27FC236}">
                <a16:creationId xmlns:a16="http://schemas.microsoft.com/office/drawing/2014/main" id="{AF64DDE0-C5F4-CFE5-7529-5DA0B497121B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end="8719.6666"/>
                </p14:media>
              </p:ext>
            </p:extLst>
          </p:nvPr>
        </p:nvPicPr>
        <p:blipFill>
          <a:blip r:embed="rId4">
            <a:lum bright="20000" contrast="20000"/>
          </a:blip>
          <a:stretch>
            <a:fillRect/>
          </a:stretch>
        </p:blipFill>
        <p:spPr>
          <a:xfrm>
            <a:off x="3293847" y="776035"/>
            <a:ext cx="6136913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00181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62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DCBEDB-E2E1-2273-5086-FFA7409012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3D402-DCCC-E47E-4597-38B2ADCA96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2</a:t>
            </a:r>
          </a:p>
        </p:txBody>
      </p:sp>
      <p:pic>
        <p:nvPicPr>
          <p:cNvPr id="3" name="Supplementary Movie S2">
            <a:hlinkClick r:id="" action="ppaction://media"/>
            <a:extLst>
              <a:ext uri="{FF2B5EF4-FFF2-40B4-BE49-F238E27FC236}">
                <a16:creationId xmlns:a16="http://schemas.microsoft.com/office/drawing/2014/main" id="{27CB698D-1853-714A-6C83-45DEF0F9634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70582" y="994126"/>
            <a:ext cx="588645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78236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784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43D05F-8811-874B-42E1-8A5C299ADF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27908-050A-99D3-6204-DC855CAF4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3</a:t>
            </a:r>
          </a:p>
        </p:txBody>
      </p:sp>
      <p:pic>
        <p:nvPicPr>
          <p:cNvPr id="5" name="Supplementary Movie S3">
            <a:hlinkClick r:id="" action="ppaction://media"/>
            <a:extLst>
              <a:ext uri="{FF2B5EF4-FFF2-40B4-BE49-F238E27FC236}">
                <a16:creationId xmlns:a16="http://schemas.microsoft.com/office/drawing/2014/main" id="{32766AF0-0B91-F91C-06D5-6C7E948F3F6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481705" y="982345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83443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62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E5F3EEF-E076-C521-5C6F-C174C3EA54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88B74-CCE6-229B-265F-7346C6A1AD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4</a:t>
            </a:r>
          </a:p>
        </p:txBody>
      </p:sp>
      <p:pic>
        <p:nvPicPr>
          <p:cNvPr id="3" name="Supplementary Movie S4">
            <a:hlinkClick r:id="" action="ppaction://media"/>
            <a:extLst>
              <a:ext uri="{FF2B5EF4-FFF2-40B4-BE49-F238E27FC236}">
                <a16:creationId xmlns:a16="http://schemas.microsoft.com/office/drawing/2014/main" id="{D8EC0D19-C487-8A10-C427-FCBE0F1F11C6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end="3590.6666"/>
                </p14:media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663953" y="908382"/>
            <a:ext cx="5887288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44820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463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3B26DF-8722-7772-126D-F96C8DD400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B6350-B223-0608-764F-43637ECF9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5</a:t>
            </a:r>
          </a:p>
        </p:txBody>
      </p:sp>
      <p:pic>
        <p:nvPicPr>
          <p:cNvPr id="3" name="Supplementary Movie S5">
            <a:hlinkClick r:id="" action="ppaction://media"/>
            <a:extLst>
              <a:ext uri="{FF2B5EF4-FFF2-40B4-BE49-F238E27FC236}">
                <a16:creationId xmlns:a16="http://schemas.microsoft.com/office/drawing/2014/main" id="{D6AD633A-9DA2-7873-21C8-0CAB3B353373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end="9537.6666"/>
                </p14:media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593142" y="908382"/>
            <a:ext cx="5502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16103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195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A403F2-AFB4-8FD4-5A5E-2B22370C62D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509D7A-5FD9-FC7D-3B07-D5C4488DE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8633"/>
            <a:ext cx="10515600" cy="729749"/>
          </a:xfrm>
        </p:spPr>
        <p:txBody>
          <a:bodyPr/>
          <a:lstStyle/>
          <a:p>
            <a:r>
              <a:rPr lang="en-US" dirty="0"/>
              <a:t>Movie S6</a:t>
            </a:r>
          </a:p>
        </p:txBody>
      </p:sp>
      <p:pic>
        <p:nvPicPr>
          <p:cNvPr id="4" name="Supplementary Movie S6">
            <a:hlinkClick r:id="" action="ppaction://media"/>
            <a:extLst>
              <a:ext uri="{FF2B5EF4-FFF2-40B4-BE49-F238E27FC236}">
                <a16:creationId xmlns:a16="http://schemas.microsoft.com/office/drawing/2014/main" id="{1345BA17-0947-0310-D8CE-92F4E5366415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4351"/>
                </p14:media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52800" y="908382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3261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64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14</Words>
  <Application>Microsoft Office PowerPoint</Application>
  <PresentationFormat>Widescreen</PresentationFormat>
  <Paragraphs>7</Paragraphs>
  <Slides>7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Supplementary Movies</vt:lpstr>
      <vt:lpstr>Movie S1</vt:lpstr>
      <vt:lpstr>Movie S2</vt:lpstr>
      <vt:lpstr>Movie S3</vt:lpstr>
      <vt:lpstr>Movie S4</vt:lpstr>
      <vt:lpstr>Movie S5</vt:lpstr>
      <vt:lpstr>Movie S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ouria Ramezani</dc:creator>
  <cp:lastModifiedBy>Félix Sauvage</cp:lastModifiedBy>
  <cp:revision>9</cp:revision>
  <dcterms:created xsi:type="dcterms:W3CDTF">2025-09-02T09:32:14Z</dcterms:created>
  <dcterms:modified xsi:type="dcterms:W3CDTF">2025-09-14T16:44:15Z</dcterms:modified>
</cp:coreProperties>
</file>